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797675" cy="9928225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Emilie" initials="E" lastIdx="2" clrIdx="0"/>
  <p:cmAuthor id="1" name="tete" initials="t" lastIdx="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3" d="100"/>
          <a:sy n="93" d="100"/>
        </p:scale>
        <p:origin x="2478" y="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05315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95233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026360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89232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302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935260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28973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26428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12049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710061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17899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101FF9-96F8-4BC5-9CE0-E32E3058E4FB}" type="datetimeFigureOut">
              <a:rPr lang="fr-FR" smtClean="0"/>
              <a:t>26/09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1624E5-D86C-4E8B-A1BA-D4A202DD42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792424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Image 12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7638" y="899592"/>
            <a:ext cx="4806315" cy="3511550"/>
          </a:xfrm>
          <a:prstGeom prst="rect">
            <a:avLst/>
          </a:prstGeom>
          <a:noFill/>
          <a:ln>
            <a:noFill/>
          </a:ln>
        </p:spPr>
      </p:pic>
      <p:pic>
        <p:nvPicPr>
          <p:cNvPr id="14" name="Image 13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4228" y="5004048"/>
            <a:ext cx="4806315" cy="3511550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/>
          <p:nvPr/>
        </p:nvSpPr>
        <p:spPr>
          <a:xfrm>
            <a:off x="1772816" y="3347864"/>
            <a:ext cx="288032" cy="2160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5" name="Connecteur droit avec flèche 4"/>
          <p:cNvCxnSpPr/>
          <p:nvPr/>
        </p:nvCxnSpPr>
        <p:spPr>
          <a:xfrm>
            <a:off x="1916832" y="3563888"/>
            <a:ext cx="0" cy="1872208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15" name="Rectangle 14"/>
          <p:cNvSpPr/>
          <p:nvPr/>
        </p:nvSpPr>
        <p:spPr>
          <a:xfrm>
            <a:off x="-8763" y="35496"/>
            <a:ext cx="6822139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Supplementary Figure 2: </a:t>
            </a:r>
            <a:r>
              <a:rPr lang="en-US" sz="12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Adjusted (for the mean of all other variables of the model) hazard ratio of death for each value of CD34</a:t>
            </a:r>
            <a:r>
              <a:rPr lang="en-US" sz="1200" baseline="300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CD38</a:t>
            </a:r>
            <a:r>
              <a:rPr lang="en-US" sz="1200" baseline="300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CD123</a:t>
            </a:r>
            <a:r>
              <a:rPr lang="en-US" sz="1200" baseline="300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 percentage. After adjustment for confounding factors (white cell count, albumin and cytogenetic risk at diagnosis), death rate significantly (P&lt;0.0001) increased from CD34</a:t>
            </a:r>
            <a:r>
              <a:rPr lang="en-US" sz="1200" baseline="300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CD38</a:t>
            </a:r>
            <a:r>
              <a:rPr lang="en-US" sz="1200" baseline="300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CD123</a:t>
            </a:r>
            <a:r>
              <a:rPr lang="en-US" sz="1200" baseline="300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 percentage &gt; 0.10% in patients treated with Intensive Chemotherapy. Dashed lines correspond to 95% confidence interval of hazard ratio.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996578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85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hème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ete</dc:creator>
  <cp:lastModifiedBy>François Vergez</cp:lastModifiedBy>
  <cp:revision>7</cp:revision>
  <cp:lastPrinted>2019-05-27T14:35:17Z</cp:lastPrinted>
  <dcterms:created xsi:type="dcterms:W3CDTF">2019-05-27T14:26:13Z</dcterms:created>
  <dcterms:modified xsi:type="dcterms:W3CDTF">2019-09-26T16:29:54Z</dcterms:modified>
</cp:coreProperties>
</file>